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40" y="-6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664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569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386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967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38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638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463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261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103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828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248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14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4">
            <a:extLst>
              <a:ext uri="{FF2B5EF4-FFF2-40B4-BE49-F238E27FC236}">
                <a16:creationId xmlns:a16="http://schemas.microsoft.com/office/drawing/2014/main" xmlns="" id="{334642AC-AA60-4EC4-87A8-4FF374378A91}"/>
              </a:ext>
            </a:extLst>
          </p:cNvPr>
          <p:cNvSpPr txBox="1"/>
          <p:nvPr/>
        </p:nvSpPr>
        <p:spPr>
          <a:xfrm>
            <a:off x="1135310" y="513952"/>
            <a:ext cx="7607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file 5. Table S5: </a:t>
            </a:r>
            <a:r>
              <a:rPr lang="en-US" sz="1200" dirty="0"/>
              <a:t>Abundances of different phyla in fish fed the experimental diets during 12 weeks. </a:t>
            </a:r>
            <a:endParaRPr lang="en-US" sz="1200" b="1" dirty="0"/>
          </a:p>
        </p:txBody>
      </p:sp>
      <p:graphicFrame>
        <p:nvGraphicFramePr>
          <p:cNvPr id="9" name="Tableau 5">
            <a:extLst>
              <a:ext uri="{FF2B5EF4-FFF2-40B4-BE49-F238E27FC236}">
                <a16:creationId xmlns:a16="http://schemas.microsoft.com/office/drawing/2014/main" xmlns="" id="{27582507-4217-4B35-B8F8-F101B756B6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5355339"/>
              </p:ext>
            </p:extLst>
          </p:nvPr>
        </p:nvGraphicFramePr>
        <p:xfrm>
          <a:off x="1219200" y="1143000"/>
          <a:ext cx="7607860" cy="318184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39984">
                  <a:extLst>
                    <a:ext uri="{9D8B030D-6E8A-4147-A177-3AD203B41FA5}">
                      <a16:colId xmlns:a16="http://schemas.microsoft.com/office/drawing/2014/main" xmlns="" val="1344384232"/>
                    </a:ext>
                  </a:extLst>
                </a:gridCol>
                <a:gridCol w="937969">
                  <a:extLst>
                    <a:ext uri="{9D8B030D-6E8A-4147-A177-3AD203B41FA5}">
                      <a16:colId xmlns:a16="http://schemas.microsoft.com/office/drawing/2014/main" xmlns="" val="841134561"/>
                    </a:ext>
                  </a:extLst>
                </a:gridCol>
                <a:gridCol w="937969">
                  <a:extLst>
                    <a:ext uri="{9D8B030D-6E8A-4147-A177-3AD203B41FA5}">
                      <a16:colId xmlns:a16="http://schemas.microsoft.com/office/drawing/2014/main" xmlns="" val="1505244022"/>
                    </a:ext>
                  </a:extLst>
                </a:gridCol>
                <a:gridCol w="937969">
                  <a:extLst>
                    <a:ext uri="{9D8B030D-6E8A-4147-A177-3AD203B41FA5}">
                      <a16:colId xmlns:a16="http://schemas.microsoft.com/office/drawing/2014/main" xmlns="" val="2867634849"/>
                    </a:ext>
                  </a:extLst>
                </a:gridCol>
                <a:gridCol w="937969">
                  <a:extLst>
                    <a:ext uri="{9D8B030D-6E8A-4147-A177-3AD203B41FA5}">
                      <a16:colId xmlns:a16="http://schemas.microsoft.com/office/drawing/2014/main" xmlns="" val="252578451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3703563700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394317734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xmlns="" val="359230154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000" b="1" dirty="0"/>
                        <a:t>Phyla</a:t>
                      </a:r>
                    </a:p>
                  </a:txBody>
                  <a:tcPr marL="62162" marR="62162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r>
                        <a:rPr lang="fr-FR" sz="1000" b="1" dirty="0"/>
                        <a:t>LS-0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r>
                        <a:rPr lang="fr-FR" sz="1000" b="1" dirty="0"/>
                        <a:t>LS-In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r>
                        <a:rPr lang="fr-FR" sz="1000" b="1" dirty="0"/>
                        <a:t>HS-0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r>
                        <a:rPr lang="fr-FR" sz="1000" b="1" dirty="0"/>
                        <a:t>HS-In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fr-FR" sz="1000" b="1" i="1" dirty="0"/>
                        <a:t>P</a:t>
                      </a:r>
                      <a:r>
                        <a:rPr lang="fr-FR" sz="1000" b="1" dirty="0"/>
                        <a:t> values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12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12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09912913"/>
                  </a:ext>
                </a:extLst>
              </a:tr>
              <a:tr h="3177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1000" i="1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162" marR="62162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dirty="0"/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dirty="0"/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dirty="0"/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dirty="0"/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b="1" dirty="0"/>
                        <a:t>CHO/</a:t>
                      </a:r>
                    </a:p>
                    <a:p>
                      <a:r>
                        <a:rPr lang="fr-FR" sz="1000" b="1" dirty="0"/>
                        <a:t>Protein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b="1" dirty="0"/>
                        <a:t>Inulin 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b="1" dirty="0"/>
                        <a:t>Interaction</a:t>
                      </a:r>
                      <a:endParaRPr lang="en-US" sz="1000" b="1" dirty="0"/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98031203"/>
                  </a:ext>
                </a:extLst>
              </a:tr>
              <a:tr h="31772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+mn-lt"/>
                        </a:rPr>
                        <a:t>Proteobacteri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72.08 ± 9.7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72.93 ± 5.4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76.47 ± 6.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81.07 ± 7.5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**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2771750117"/>
                  </a:ext>
                </a:extLst>
              </a:tr>
              <a:tr h="31772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+mn-lt"/>
                        </a:rPr>
                        <a:t>Firmicute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21.40 ± 10.2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21.19 ± 6.9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15.99 ± 4.5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11.34 ± 5.4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***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767489681"/>
                  </a:ext>
                </a:extLst>
              </a:tr>
              <a:tr h="31772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+mn-lt"/>
                        </a:rPr>
                        <a:t>Actinobacteriot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6.22 ± 2.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5.56 ± 2.5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7.22 ± 3.3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7.25 ± 2.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  <a:latin typeface="+mn-lt"/>
                        </a:rPr>
                        <a:t>N</a:t>
                      </a:r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815794714"/>
                  </a:ext>
                </a:extLst>
              </a:tr>
              <a:tr h="31772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+mn-lt"/>
                        </a:rPr>
                        <a:t>Bacteroidot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22 ± 0.1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26 ± 0.4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24 ± 0.3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28 ± 0.2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  <a:latin typeface="+mn-lt"/>
                        </a:rPr>
                        <a:t>N</a:t>
                      </a:r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2579671498"/>
                  </a:ext>
                </a:extLst>
              </a:tr>
              <a:tr h="31772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+mn-lt"/>
                        </a:rPr>
                        <a:t>Fusobacteriot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06 ± 0.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04 ± 0.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05 ± 0.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02 ± 0.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  <a:latin typeface="+mn-lt"/>
                        </a:rPr>
                        <a:t>N</a:t>
                      </a:r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3576332884"/>
                  </a:ext>
                </a:extLst>
              </a:tr>
              <a:tr h="31772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+mn-lt"/>
                        </a:rPr>
                        <a:t>Acidobacteriot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01 ± 0.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02 ± 0.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 ± 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04 ± 0.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  <a:latin typeface="+mn-lt"/>
                        </a:rPr>
                        <a:t>N</a:t>
                      </a:r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714583882"/>
                  </a:ext>
                </a:extLst>
              </a:tr>
              <a:tr h="31772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>
                          <a:effectLst/>
                          <a:latin typeface="+mn-lt"/>
                        </a:rPr>
                        <a:t>Patescibacteri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01 ± 0.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 ± 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04 ± 0.0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 ± 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  <a:latin typeface="+mn-lt"/>
                        </a:rPr>
                        <a:t>N</a:t>
                      </a:r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33129134"/>
                  </a:ext>
                </a:extLst>
              </a:tr>
              <a:tr h="31772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  <a:r>
                        <a:rPr lang="fr-F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rmicutes/</a:t>
                      </a:r>
                      <a:r>
                        <a:rPr lang="en-US" sz="1100" i="1" u="none" strike="noStrike" dirty="0">
                          <a:effectLst/>
                          <a:latin typeface="+mn-lt"/>
                        </a:rPr>
                        <a:t>Proteobacteria</a:t>
                      </a:r>
                      <a:r>
                        <a:rPr lang="fr-F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ratio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32 ± 0.2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30 ± 0.1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21 ± 0.0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0.15 ± 0.0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**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1648317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19264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9</Words>
  <Application>Microsoft Office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eta Decipolo</dc:creator>
  <cp:lastModifiedBy>Antonieta Decipolo</cp:lastModifiedBy>
  <cp:revision>3</cp:revision>
  <dcterms:created xsi:type="dcterms:W3CDTF">2023-10-23T00:05:00Z</dcterms:created>
  <dcterms:modified xsi:type="dcterms:W3CDTF">2023-10-23T00:07:27Z</dcterms:modified>
</cp:coreProperties>
</file>